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461" r:id="rId5"/>
    <p:sldId id="462" r:id="rId6"/>
  </p:sldIdLst>
  <p:sldSz cx="6858000" cy="9144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256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ang, Qiwei" initials="YQ" lastIdx="1" clrIdx="0">
    <p:extLst>
      <p:ext uri="{19B8F6BF-5375-455C-9EA6-DF929625EA0E}">
        <p15:presenceInfo xmlns:p15="http://schemas.microsoft.com/office/powerpoint/2012/main" userId="S-1-5-21-1454471165-2000478354-1801674531-51683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533FF"/>
    <a:srgbClr val="FF9A9B"/>
    <a:srgbClr val="A3A3A3"/>
    <a:srgbClr val="9A99FF"/>
    <a:srgbClr val="8BBA8C"/>
    <a:srgbClr val="4370C1"/>
    <a:srgbClr val="E97B2F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499" autoAdjust="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>
        <p:guide orient="horz" pos="2256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696" tIns="46849" rIns="93696" bIns="46849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696" tIns="46849" rIns="93696" bIns="46849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  <a:cs typeface="+mn-cs"/>
              </a:defRPr>
            </a:lvl1pPr>
          </a:lstStyle>
          <a:p>
            <a:pPr>
              <a:defRPr/>
            </a:pPr>
            <a:fld id="{092B0B49-057D-464E-9E09-55D519330BF3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8500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696" tIns="46849" rIns="93696" bIns="46849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696" tIns="46849" rIns="93696" bIns="46849" rtlCol="0"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696" tIns="46849" rIns="93696" bIns="46849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696" tIns="46849" rIns="93696" bIns="46849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  <a:cs typeface="+mn-cs"/>
              </a:defRPr>
            </a:lvl1pPr>
          </a:lstStyle>
          <a:p>
            <a:pPr>
              <a:defRPr/>
            </a:pPr>
            <a:fld id="{94E9E508-D54B-4C0E-957A-AE5F1A5FAE9C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596929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5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375F3F-F7FF-4512-983D-9DFF104FBDF4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77C755-EC8B-43DD-B6E0-89732F086AB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6B8F87-7E87-4F45-ACD4-51EB76FF21EA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4B6318-2816-4D0D-898E-5C28CD6004F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7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7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A346ED-42B3-44D0-8C34-8248C04BDC18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94B3FD-B18E-4E6C-9A00-08ABF97CE22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89078A-D90A-43F9-9959-A9EE9734E1FD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60E789-4DB7-422C-A3F8-6ABD71672D97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7F667B-6DD8-4D4B-93EA-7373ABE2EDC6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9C6A25-E574-4F5A-8D68-815D38E0F2B6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7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7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CD5922-016B-4F9D-B067-CAA5BC5315E6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B78B13-BCBA-429D-995F-50A43F05F16F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8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8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1E7E8D-9A2C-43FF-A95B-9B7E16606998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18CEB2-F20C-4471-8999-B7A2223EF8E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C88CC2-98FE-4A12-9A8A-D096529FD3CA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D819F2-FF49-49B5-8A33-270F88B4B13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BA5B87-BE27-4B76-B520-43100B20C659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FF6FBA-7198-4C49-97AB-A03DDAC70BF2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00" y="364072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1" y="1913472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A1B2A8-7760-4A94-B316-CC0E371BC9F4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D10873-7FD3-4CDA-96E8-CE8FD2686187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D75553-3D20-4E20-A2FC-94EDBFAADE96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615164-9E0C-4BD5-95D3-D5289B08F83A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319091E3-E6A0-4EC9-9F8F-2DE6364881A0}" type="datetimeFigureOut">
              <a:rPr lang="en-US"/>
              <a:pPr>
                <a:defRPr/>
              </a:pPr>
              <a:t>7/19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3E785EF8-9805-475F-8B96-CE8765079E95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D6A6088D-9BBD-C4F6-8F18-77E1DEFBC3C0}"/>
              </a:ext>
            </a:extLst>
          </p:cNvPr>
          <p:cNvGrpSpPr/>
          <p:nvPr/>
        </p:nvGrpSpPr>
        <p:grpSpPr>
          <a:xfrm>
            <a:off x="289367" y="1180618"/>
            <a:ext cx="3139634" cy="4368785"/>
            <a:chOff x="289367" y="1180618"/>
            <a:chExt cx="3139634" cy="4368785"/>
          </a:xfrm>
        </p:grpSpPr>
        <p:sp>
          <p:nvSpPr>
            <p:cNvPr id="4" name="TextBox 3"/>
            <p:cNvSpPr txBox="1"/>
            <p:nvPr/>
          </p:nvSpPr>
          <p:spPr>
            <a:xfrm>
              <a:off x="410042" y="5287793"/>
              <a:ext cx="6618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sz="1100" b="1" dirty="0">
                <a:solidFill>
                  <a:srgbClr val="FF0000"/>
                </a:solidFill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7FE8901-490C-42FE-8FB8-407B103FE666}"/>
                </a:ext>
              </a:extLst>
            </p:cNvPr>
            <p:cNvSpPr txBox="1"/>
            <p:nvPr/>
          </p:nvSpPr>
          <p:spPr>
            <a:xfrm>
              <a:off x="504017" y="4186960"/>
              <a:ext cx="2924984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000" b="1"/>
                <a:t>Figure S1</a:t>
              </a:r>
              <a:r>
                <a:rPr lang="en-US" sz="1000" b="1" dirty="0"/>
                <a:t>.  Validation of IRGs expression. </a:t>
              </a:r>
              <a:r>
                <a:rPr lang="en-US" sz="1000" dirty="0"/>
                <a:t>q-PCR was performed to compare the expression of IRGs (</a:t>
              </a:r>
              <a:r>
                <a:rPr lang="en-US" sz="1000" i="1" dirty="0"/>
                <a:t>ccl2</a:t>
              </a:r>
              <a:r>
                <a:rPr lang="en-US" sz="1000" dirty="0"/>
                <a:t>, </a:t>
              </a:r>
              <a:r>
                <a:rPr lang="en-US" sz="1000" i="1" dirty="0"/>
                <a:t>ccl7</a:t>
              </a:r>
              <a:r>
                <a:rPr lang="en-US" sz="1000" dirty="0"/>
                <a:t>, </a:t>
              </a:r>
              <a:r>
                <a:rPr lang="en-US" sz="1000" i="1" dirty="0"/>
                <a:t>lpar1,</a:t>
              </a:r>
              <a:r>
                <a:rPr lang="en-US" sz="1000" dirty="0"/>
                <a:t> and </a:t>
              </a:r>
              <a:r>
                <a:rPr lang="en-US" sz="1000" i="1" dirty="0" err="1"/>
                <a:t>pdpn</a:t>
              </a:r>
              <a:r>
                <a:rPr lang="en-US" sz="1000" dirty="0"/>
                <a:t>) between DES-MMSCs and VEH-MMSCs. *p&lt;0.05, **p&lt;0.01, ***p&lt;0.001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098AA57-46F6-1BFB-381F-DAFD66E9A4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51293"/>
            <a:stretch/>
          </p:blipFill>
          <p:spPr>
            <a:xfrm>
              <a:off x="504017" y="1180618"/>
              <a:ext cx="2660598" cy="2505673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5476128-65BB-4C8F-FAEB-2548EF38252A}"/>
                </a:ext>
              </a:extLst>
            </p:cNvPr>
            <p:cNvSpPr txBox="1"/>
            <p:nvPr/>
          </p:nvSpPr>
          <p:spPr>
            <a:xfrm>
              <a:off x="289367" y="1180618"/>
              <a:ext cx="661882" cy="5440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DEEA284-ECA3-B53D-C468-FC84A6D360D6}"/>
              </a:ext>
            </a:extLst>
          </p:cNvPr>
          <p:cNvSpPr txBox="1"/>
          <p:nvPr/>
        </p:nvSpPr>
        <p:spPr>
          <a:xfrm rot="16200000">
            <a:off x="-442517" y="2476395"/>
            <a:ext cx="221944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/>
              <a:t>Relative normalized gene express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86CDDC-3DEC-FC23-BC73-BCF462CC3EF2}"/>
              </a:ext>
            </a:extLst>
          </p:cNvPr>
          <p:cNvSpPr txBox="1"/>
          <p:nvPr/>
        </p:nvSpPr>
        <p:spPr>
          <a:xfrm>
            <a:off x="1193844" y="2072640"/>
            <a:ext cx="93936" cy="13311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E20C55F-FD44-A652-D3ED-0FA713E442AA}"/>
              </a:ext>
            </a:extLst>
          </p:cNvPr>
          <p:cNvSpPr txBox="1"/>
          <p:nvPr/>
        </p:nvSpPr>
        <p:spPr>
          <a:xfrm>
            <a:off x="1071924" y="3459050"/>
            <a:ext cx="221944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i="1" dirty="0"/>
              <a:t>Ccl2        Ccl7         Lpar1       </a:t>
            </a:r>
            <a:r>
              <a:rPr lang="en-US" sz="900" b="1" i="1" dirty="0" err="1"/>
              <a:t>Pdpn</a:t>
            </a:r>
            <a:endParaRPr lang="en-US" sz="900" b="1" i="1" dirty="0"/>
          </a:p>
        </p:txBody>
      </p:sp>
    </p:spTree>
    <p:extLst>
      <p:ext uri="{BB962C8B-B14F-4D97-AF65-F5344CB8AC3E}">
        <p14:creationId xmlns:p14="http://schemas.microsoft.com/office/powerpoint/2010/main" val="2123047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DCEAF01-A714-C1CD-71A5-B0828B075D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141" y="1313793"/>
            <a:ext cx="4939329" cy="704948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8B7E582-A53B-7C6A-BFF3-787926A9E7A5}"/>
              </a:ext>
            </a:extLst>
          </p:cNvPr>
          <p:cNvSpPr txBox="1"/>
          <p:nvPr/>
        </p:nvSpPr>
        <p:spPr>
          <a:xfrm>
            <a:off x="855012" y="903890"/>
            <a:ext cx="4151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l Table S1. Primers used in this study</a:t>
            </a:r>
          </a:p>
        </p:txBody>
      </p:sp>
    </p:spTree>
    <p:extLst>
      <p:ext uri="{BB962C8B-B14F-4D97-AF65-F5344CB8AC3E}">
        <p14:creationId xmlns:p14="http://schemas.microsoft.com/office/powerpoint/2010/main" val="3217365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81FA181D07A0E44BC242919BF3A0629" ma:contentTypeVersion="2" ma:contentTypeDescription="Create a new document." ma:contentTypeScope="" ma:versionID="749c7815dab5c2a34443ccfd562b3e31">
  <xsd:schema xmlns:xsd="http://www.w3.org/2001/XMLSchema" xmlns:xs="http://www.w3.org/2001/XMLSchema" xmlns:p="http://schemas.microsoft.com/office/2006/metadata/properties" xmlns:ns3="6f352ce0-6cf7-490c-b22c-81aaae135571" targetNamespace="http://schemas.microsoft.com/office/2006/metadata/properties" ma:root="true" ma:fieldsID="52e37d639ba052eb816fb439e6da2b40" ns3:_="">
    <xsd:import namespace="6f352ce0-6cf7-490c-b22c-81aaae13557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f352ce0-6cf7-490c-b22c-81aaae13557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607EE156-14B3-4441-AA96-451BC2FC8E16}">
  <ds:schemaRefs>
    <ds:schemaRef ds:uri="http://schemas.microsoft.com/office/2006/documentManagement/types"/>
    <ds:schemaRef ds:uri="http://schemas.microsoft.com/office/2006/metadata/properties"/>
    <ds:schemaRef ds:uri="http://purl.org/dc/terms/"/>
    <ds:schemaRef ds:uri="http://schemas.microsoft.com/office/infopath/2007/PartnerControls"/>
    <ds:schemaRef ds:uri="http://purl.org/dc/elements/1.1/"/>
    <ds:schemaRef ds:uri="http://purl.org/dc/dcmitype/"/>
    <ds:schemaRef ds:uri="http://schemas.openxmlformats.org/package/2006/metadata/core-properties"/>
    <ds:schemaRef ds:uri="6f352ce0-6cf7-490c-b22c-81aaae135571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3DE5ED6B-0184-4005-8F56-CBF9E3A6F66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f352ce0-6cf7-490c-b22c-81aaae13557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5D58682-3D91-4B3E-8D1D-95D6E4EE288F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9424</TotalTime>
  <Words>63</Words>
  <Application>Microsoft Office PowerPoint</Application>
  <PresentationFormat>On-screen Show (4:3)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qiwei Yang</dc:creator>
  <cp:lastModifiedBy>MDPI</cp:lastModifiedBy>
  <cp:revision>1158</cp:revision>
  <cp:lastPrinted>2020-04-15T20:57:01Z</cp:lastPrinted>
  <dcterms:created xsi:type="dcterms:W3CDTF">2014-04-16T22:38:59Z</dcterms:created>
  <dcterms:modified xsi:type="dcterms:W3CDTF">2023-07-19T07:39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81FA181D07A0E44BC242919BF3A0629</vt:lpwstr>
  </property>
</Properties>
</file>